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8000663" cy="9720263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55600" y="685440"/>
            <a:ext cx="63482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69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360360"/>
                <a:tab algn="l" pos="720720"/>
                <a:tab algn="l" pos="1081080"/>
                <a:tab algn="l" pos="1441440"/>
                <a:tab algn="l" pos="1801800"/>
                <a:tab algn="l" pos="2162160"/>
                <a:tab algn="l" pos="2522520"/>
                <a:tab algn="l" pos="2882880"/>
                <a:tab algn="l" pos="3243240"/>
                <a:tab algn="l" pos="3603600"/>
                <a:tab algn="l" pos="3963960"/>
                <a:tab algn="l" pos="4324320"/>
                <a:tab algn="l" pos="4684680"/>
                <a:tab algn="l" pos="5045040"/>
                <a:tab algn="l" pos="5405400"/>
                <a:tab algn="l" pos="5765760"/>
                <a:tab algn="l" pos="6126120"/>
                <a:tab algn="l" pos="6486480"/>
                <a:tab algn="l" pos="6846840"/>
                <a:tab algn="l" pos="72072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fld id="{02E2BDF2-778F-4FB9-9276-17F2806579F4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255600" y="685800"/>
            <a:ext cx="6348240" cy="342900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374"/>
              </a:spcBef>
              <a:buNone/>
              <a:tabLst>
                <a:tab algn="l" pos="0"/>
                <a:tab algn="l" pos="360360"/>
                <a:tab algn="l" pos="720720"/>
                <a:tab algn="l" pos="1081080"/>
                <a:tab algn="l" pos="1441440"/>
                <a:tab algn="l" pos="1801800"/>
                <a:tab algn="l" pos="2162160"/>
                <a:tab algn="l" pos="2522520"/>
                <a:tab algn="l" pos="2882880"/>
                <a:tab algn="l" pos="3243240"/>
                <a:tab algn="l" pos="3603600"/>
                <a:tab algn="l" pos="3963960"/>
                <a:tab algn="l" pos="4324320"/>
                <a:tab algn="l" pos="4684680"/>
                <a:tab algn="l" pos="5045040"/>
                <a:tab algn="l" pos="5405400"/>
                <a:tab algn="l" pos="5765760"/>
                <a:tab algn="l" pos="6126120"/>
                <a:tab algn="l" pos="6486480"/>
                <a:tab algn="l" pos="6846840"/>
                <a:tab algn="l" pos="7207200"/>
              </a:tabLst>
            </a:pPr>
            <a:endParaRPr b="0" lang="it-IT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fld id="{6C828A52-3D67-4451-8D94-26AF0AF30F0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12B8D8-8E59-4545-9D6E-1E1284C9FF4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1620072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900000" y="5619600"/>
            <a:ext cx="1620072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C88BA-BD51-4931-A93A-8C6873C4F55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9201240" y="226836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900000" y="561960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9201240" y="561960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E48690-ED50-498F-81BD-E058E6ABC99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52164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6377760" y="2268360"/>
            <a:ext cx="52164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11855160" y="2268360"/>
            <a:ext cx="52164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900000" y="5619600"/>
            <a:ext cx="52164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6377760" y="5619600"/>
            <a:ext cx="52164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11855160" y="5619600"/>
            <a:ext cx="52164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4DA962-03BA-4162-B937-F5A6DF8DD2A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900000" y="2268360"/>
            <a:ext cx="16200720" cy="6415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250"/>
              </a:spcBef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ABBD33-B408-406B-A466-90049DC447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16200720" cy="641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6AA309-4B7D-408A-8B22-92DC90C658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7905600" cy="641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9201240" y="2268360"/>
            <a:ext cx="7905600" cy="641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DA7B11-1DB8-4C62-90B2-3CF7E5A0383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9C3AC-878F-463F-A00D-38D77658D84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900000" y="388440"/>
            <a:ext cx="16200720" cy="7515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250"/>
              </a:spcBef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7764C2-7E0C-43F4-A794-56AD2F3349B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9201240" y="2268360"/>
            <a:ext cx="7905600" cy="641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900000" y="561960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A911FD-840C-4B13-B296-D372B828B8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7905600" cy="641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9201240" y="226836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9201240" y="561960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027F2-9F9F-4472-A087-9843C1A01FF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900000" y="226836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9201240" y="2268360"/>
            <a:ext cx="790560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900000" y="5619600"/>
            <a:ext cx="16200720" cy="30600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/>
          </a:bodyPr>
          <a:p>
            <a:pPr indent="0">
              <a:spcBef>
                <a:spcPts val="1250"/>
              </a:spcBef>
              <a:buNone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6D2A2A-F910-47D6-818B-D22572083D3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900000" y="388440"/>
            <a:ext cx="16200720" cy="16210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 algn="ctr">
              <a:buNone/>
              <a:tabLst>
                <a:tab algn="l" pos="0"/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69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6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900000" y="2268360"/>
            <a:ext cx="16200720" cy="641520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t">
            <a:normAutofit fontScale="99000"/>
          </a:bodyPr>
          <a:p>
            <a:pPr marL="541800" indent="-541800"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1" marL="1175400" indent="-450720">
              <a:spcBef>
                <a:spcPts val="1250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2" marL="1809000" indent="-361440">
              <a:spcBef>
                <a:spcPts val="1250"/>
              </a:spcBef>
              <a:buClr>
                <a:srgbClr val="000000"/>
              </a:buClr>
              <a:buFont typeface="Arial"/>
              <a:buChar char="•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3" marL="2532960" indent="-361080">
              <a:spcBef>
                <a:spcPts val="1250"/>
              </a:spcBef>
              <a:buClr>
                <a:srgbClr val="000000"/>
              </a:buClr>
              <a:buFont typeface="Arial"/>
              <a:buChar char="–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4" marL="3257640" indent="-36108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5" marL="3257640" indent="-36108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  <a:p>
            <a:pPr lvl="6" marL="3257640" indent="-361080">
              <a:spcBef>
                <a:spcPts val="1250"/>
              </a:spcBef>
              <a:buClr>
                <a:srgbClr val="000000"/>
              </a:buClr>
              <a:buFont typeface="Arial"/>
              <a:buChar char="»"/>
              <a:tabLst>
                <a:tab algn="l" pos="730080"/>
                <a:tab algn="l" pos="1460520"/>
                <a:tab algn="l" pos="2190600"/>
                <a:tab algn="l" pos="2921040"/>
                <a:tab algn="l" pos="3651120"/>
                <a:tab algn="l" pos="4381560"/>
                <a:tab algn="l" pos="5111640"/>
                <a:tab algn="l" pos="5842080"/>
                <a:tab algn="l" pos="6572160"/>
                <a:tab algn="l" pos="7302600"/>
                <a:tab algn="l" pos="8032680"/>
                <a:tab algn="l" pos="8763120"/>
                <a:tab algn="l" pos="9493200"/>
                <a:tab algn="l" pos="10223640"/>
                <a:tab algn="l" pos="10953720"/>
              </a:tabLst>
            </a:pPr>
            <a:r>
              <a:rPr b="0" lang="en-US" sz="50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5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900000" y="9009000"/>
            <a:ext cx="4200480" cy="5176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en-US" sz="19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6149880" y="9009000"/>
            <a:ext cx="5700960" cy="5176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p>
            <a:pPr indent="0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12899520" y="9009000"/>
            <a:ext cx="4200840" cy="517680"/>
          </a:xfrm>
          <a:prstGeom prst="rect">
            <a:avLst/>
          </a:prstGeom>
          <a:noFill/>
          <a:ln w="0">
            <a:noFill/>
          </a:ln>
        </p:spPr>
        <p:txBody>
          <a:bodyPr lIns="146160" rIns="146160" tIns="73080" bIns="73080" anchor="ctr">
            <a:noAutofit/>
          </a:bodyPr>
          <a:lstStyle>
            <a:lvl1pPr indent="0" algn="r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  <a:defRPr b="0" lang="en-US" sz="19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fld id="{5FC414D0-E6B6-4221-9706-F2B0BF798EDA}" type="slidenum">
              <a:rPr b="0" lang="en-US" sz="19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9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slideLayout" Target="../slideLayouts/slideLayout1.xml"/><Relationship Id="rId5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ttangolo 1"/>
          <p:cNvSpPr/>
          <p:nvPr/>
        </p:nvSpPr>
        <p:spPr>
          <a:xfrm>
            <a:off x="250920" y="1219320"/>
            <a:ext cx="17332200" cy="685152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9" name="Grafico 2" descr=""/>
          <p:cNvPicPr/>
          <p:nvPr/>
        </p:nvPicPr>
        <p:blipFill>
          <a:blip r:embed="rId1"/>
          <a:stretch/>
        </p:blipFill>
        <p:spPr>
          <a:xfrm>
            <a:off x="6467400" y="2395440"/>
            <a:ext cx="4902120" cy="4498920"/>
          </a:xfrm>
          <a:prstGeom prst="rect">
            <a:avLst/>
          </a:prstGeom>
          <a:ln w="0">
            <a:noFill/>
          </a:ln>
        </p:spPr>
      </p:pic>
      <p:sp>
        <p:nvSpPr>
          <p:cNvPr id="50" name="CasellaDiTesto 18"/>
          <p:cNvSpPr/>
          <p:nvPr/>
        </p:nvSpPr>
        <p:spPr>
          <a:xfrm rot="16200000">
            <a:off x="4596840" y="4426200"/>
            <a:ext cx="326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Alizarin red S staining (% of control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Straight Connector 21"/>
          <p:cNvSpPr/>
          <p:nvPr/>
        </p:nvSpPr>
        <p:spPr>
          <a:xfrm flipH="1">
            <a:off x="7292880" y="3660840"/>
            <a:ext cx="92160" cy="190440"/>
          </a:xfrm>
          <a:prstGeom prst="line">
            <a:avLst/>
          </a:prstGeom>
          <a:ln w="76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Line 94"/>
          <p:cNvSpPr/>
          <p:nvPr/>
        </p:nvSpPr>
        <p:spPr>
          <a:xfrm flipH="1">
            <a:off x="7273800" y="3672000"/>
            <a:ext cx="68400" cy="137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Line 95"/>
          <p:cNvSpPr/>
          <p:nvPr/>
        </p:nvSpPr>
        <p:spPr>
          <a:xfrm flipH="1">
            <a:off x="7345080" y="3672000"/>
            <a:ext cx="68040" cy="1378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54" name="Chart 36" descr=""/>
          <p:cNvPicPr/>
          <p:nvPr/>
        </p:nvPicPr>
        <p:blipFill>
          <a:blip r:embed="rId2"/>
          <a:stretch/>
        </p:blipFill>
        <p:spPr>
          <a:xfrm>
            <a:off x="1116000" y="2170080"/>
            <a:ext cx="4662360" cy="4827600"/>
          </a:xfrm>
          <a:prstGeom prst="rect">
            <a:avLst/>
          </a:prstGeom>
          <a:ln w="0">
            <a:noFill/>
          </a:ln>
        </p:spPr>
      </p:pic>
      <p:sp>
        <p:nvSpPr>
          <p:cNvPr id="55" name="CasellaDiTesto 67"/>
          <p:cNvSpPr/>
          <p:nvPr/>
        </p:nvSpPr>
        <p:spPr>
          <a:xfrm>
            <a:off x="735120" y="6657840"/>
            <a:ext cx="586548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   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S1P (log M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           </a:t>
            </a:r>
            <a:r>
              <a:rPr b="0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6                                    -5               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6" name="CasellaDiTesto 18"/>
          <p:cNvSpPr/>
          <p:nvPr/>
        </p:nvSpPr>
        <p:spPr>
          <a:xfrm rot="16200000">
            <a:off x="-781560" y="4426200"/>
            <a:ext cx="326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Oil red O staining (% of control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7" name="Straight Connector 21"/>
          <p:cNvSpPr/>
          <p:nvPr/>
        </p:nvSpPr>
        <p:spPr>
          <a:xfrm flipH="1">
            <a:off x="7292880" y="6461280"/>
            <a:ext cx="92160" cy="190440"/>
          </a:xfrm>
          <a:prstGeom prst="line">
            <a:avLst/>
          </a:prstGeom>
          <a:ln w="76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8" name="Line 94"/>
          <p:cNvSpPr/>
          <p:nvPr/>
        </p:nvSpPr>
        <p:spPr>
          <a:xfrm flipH="1">
            <a:off x="7273800" y="6470640"/>
            <a:ext cx="68400" cy="138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Line 95"/>
          <p:cNvSpPr/>
          <p:nvPr/>
        </p:nvSpPr>
        <p:spPr>
          <a:xfrm flipH="1">
            <a:off x="7345080" y="6470640"/>
            <a:ext cx="68040" cy="138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0" name="Straight Connector 21"/>
          <p:cNvSpPr/>
          <p:nvPr/>
        </p:nvSpPr>
        <p:spPr>
          <a:xfrm flipH="1">
            <a:off x="1882800" y="3220920"/>
            <a:ext cx="92160" cy="190440"/>
          </a:xfrm>
          <a:prstGeom prst="line">
            <a:avLst/>
          </a:prstGeom>
          <a:ln w="76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1" name="Line 94"/>
          <p:cNvSpPr/>
          <p:nvPr/>
        </p:nvSpPr>
        <p:spPr>
          <a:xfrm flipH="1">
            <a:off x="1863720" y="3232080"/>
            <a:ext cx="68400" cy="138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2" name="Line 95"/>
          <p:cNvSpPr/>
          <p:nvPr/>
        </p:nvSpPr>
        <p:spPr>
          <a:xfrm flipH="1">
            <a:off x="1935000" y="3232080"/>
            <a:ext cx="68400" cy="138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Straight Connector 21"/>
          <p:cNvSpPr/>
          <p:nvPr/>
        </p:nvSpPr>
        <p:spPr>
          <a:xfrm flipH="1">
            <a:off x="1882800" y="6450120"/>
            <a:ext cx="92160" cy="190440"/>
          </a:xfrm>
          <a:prstGeom prst="line">
            <a:avLst/>
          </a:prstGeom>
          <a:ln w="7632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Line 94"/>
          <p:cNvSpPr/>
          <p:nvPr/>
        </p:nvSpPr>
        <p:spPr>
          <a:xfrm flipH="1">
            <a:off x="1863720" y="6459480"/>
            <a:ext cx="68400" cy="138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5" name="Line 95"/>
          <p:cNvSpPr/>
          <p:nvPr/>
        </p:nvSpPr>
        <p:spPr>
          <a:xfrm flipH="1">
            <a:off x="1935000" y="6459480"/>
            <a:ext cx="68400" cy="1382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6" name="CasellaDiTesto 67"/>
          <p:cNvSpPr/>
          <p:nvPr/>
        </p:nvSpPr>
        <p:spPr>
          <a:xfrm>
            <a:off x="6094080" y="6657840"/>
            <a:ext cx="5915520" cy="3070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      </a:t>
            </a: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S1P (log M)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                               </a:t>
            </a:r>
            <a:r>
              <a:rPr b="0" lang="en-US" sz="1400" spc="-1" strike="noStrike">
                <a:solidFill>
                  <a:srgbClr val="ff0000"/>
                </a:solidFill>
                <a:latin typeface="Arial"/>
                <a:ea typeface="Arial"/>
              </a:rPr>
              <a:t>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-6                                   -5               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TextBox 110"/>
          <p:cNvSpPr/>
          <p:nvPr/>
        </p:nvSpPr>
        <p:spPr>
          <a:xfrm>
            <a:off x="685080" y="22622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TextBox 110"/>
          <p:cNvSpPr/>
          <p:nvPr/>
        </p:nvSpPr>
        <p:spPr>
          <a:xfrm>
            <a:off x="6064200" y="22622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69" name="Grafico 27" descr=""/>
          <p:cNvPicPr/>
          <p:nvPr/>
        </p:nvPicPr>
        <p:blipFill>
          <a:blip r:embed="rId3"/>
          <a:stretch/>
        </p:blipFill>
        <p:spPr>
          <a:xfrm>
            <a:off x="11356920" y="2395440"/>
            <a:ext cx="5735520" cy="5419800"/>
          </a:xfrm>
          <a:prstGeom prst="rect">
            <a:avLst/>
          </a:prstGeom>
          <a:ln w="0">
            <a:noFill/>
          </a:ln>
        </p:spPr>
      </p:pic>
      <p:sp>
        <p:nvSpPr>
          <p:cNvPr id="70" name="CasellaDiTesto 18"/>
          <p:cNvSpPr/>
          <p:nvPr/>
        </p:nvSpPr>
        <p:spPr>
          <a:xfrm rot="16200000">
            <a:off x="9817920" y="4453200"/>
            <a:ext cx="3260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0" lang="it-IT" sz="1400" spc="-1" strike="noStrike">
                <a:solidFill>
                  <a:srgbClr val="000000"/>
                </a:solidFill>
                <a:latin typeface="Arial"/>
                <a:ea typeface="Arial"/>
              </a:rPr>
              <a:t>T-cells proliferation (% of T-cells only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110"/>
          <p:cNvSpPr/>
          <p:nvPr/>
        </p:nvSpPr>
        <p:spPr>
          <a:xfrm>
            <a:off x="11284920" y="226224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576360"/>
                <a:tab algn="l" pos="1152360"/>
                <a:tab algn="l" pos="1728720"/>
                <a:tab algn="l" pos="2305080"/>
                <a:tab algn="l" pos="2881440"/>
                <a:tab algn="l" pos="3457440"/>
                <a:tab algn="l" pos="4033800"/>
                <a:tab algn="l" pos="4610160"/>
                <a:tab algn="l" pos="5186520"/>
                <a:tab algn="l" pos="5762520"/>
                <a:tab algn="l" pos="6338880"/>
                <a:tab algn="l" pos="6915240"/>
                <a:tab algn="l" pos="7491240"/>
                <a:tab algn="l" pos="8067600"/>
                <a:tab algn="l" pos="8643960"/>
                <a:tab algn="l" pos="9220320"/>
                <a:tab algn="l" pos="9796320"/>
                <a:tab algn="l" pos="10372680"/>
                <a:tab algn="l" pos="1094904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50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12-23T08:48:02Z</dcterms:created>
  <dc:creator>Giulio Innamorati</dc:creator>
  <dc:description/>
  <dc:language>en-US</dc:language>
  <cp:lastModifiedBy>shanmugam.s</cp:lastModifiedBy>
  <cp:lastPrinted>2017-01-10T10:08:55Z</cp:lastPrinted>
  <dcterms:modified xsi:type="dcterms:W3CDTF">2017-07-07T14:34:11Z</dcterms:modified>
  <cp:revision>407</cp:revision>
  <dc:subject/>
  <dc:title>PowerPoint Presentation</dc:title>
</cp:coreProperties>
</file>